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0AB177-12B6-453E-BDE8-B61AAAF1454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3E40EE-2FA8-47E5-A88F-3DE63FF8C65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0F39CC-164D-4D1A-86AC-26E29E2AC19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AA40BB-C0F2-458A-B2FE-45D5FE8EC19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674128-BB12-49D8-AA80-D172691ADAA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626CF6-6EDD-45CF-9369-700FB13086A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83765E-3883-40F5-BEC8-64D9D277338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EBA613-14DF-4E98-ABD5-50436BA652C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A3F609-B978-4751-AAA6-049D7FE64C8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C95707-368A-4B45-8D55-252F8B0EAF0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AE888A-EBDC-4B41-8493-057AC7197B8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A91E89-7337-46A7-968C-1D0609F8D3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8757E24-D21A-4BCD-ADE0-37124C031DE8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5"/>
          <p:cNvSpPr/>
          <p:nvPr/>
        </p:nvSpPr>
        <p:spPr>
          <a:xfrm>
            <a:off x="205920" y="5661000"/>
            <a:ext cx="8884440" cy="1134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DSC thermograms of (A) milled straw predried and measured in atmospheric pan with pin-hole,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(B) milled straw in medium pressure sealed pan at 0.10 ml/g water content,  (C) at 0.25 ml/g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water content, (D) at 1 ml/g with 0.1M H</a:t>
            </a:r>
            <a:r>
              <a:rPr b="0" lang="en-GB" sz="16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SO</a:t>
            </a:r>
            <a:r>
              <a:rPr b="0" lang="en-GB" sz="1600" spc="-1" strike="noStrike" baseline="-25000">
                <a:solidFill>
                  <a:srgbClr val="000000"/>
                </a:solidFill>
                <a:latin typeface="Calibri"/>
              </a:rPr>
              <a:t>4</a:t>
            </a: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, and also (E) extracted hemicellulose  in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medium pressure pan at 2mls/g in 0.2M H</a:t>
            </a:r>
            <a:r>
              <a:rPr b="0" lang="en-GB" sz="1600" spc="-1" strike="noStrike" baseline="-25000">
                <a:solidFill>
                  <a:srgbClr val="000000"/>
                </a:solidFill>
                <a:latin typeface="Calibri"/>
              </a:rPr>
              <a:t>2</a:t>
            </a: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SO</a:t>
            </a:r>
            <a:r>
              <a:rPr b="0" lang="en-GB" sz="1600" spc="-1" strike="noStrike" baseline="-25000">
                <a:solidFill>
                  <a:srgbClr val="000000"/>
                </a:solidFill>
                <a:latin typeface="Calibri"/>
              </a:rPr>
              <a:t>4</a:t>
            </a: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. Example of lignin relaxation peak (*) is rescaled for clarity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4" descr=""/>
          <p:cNvPicPr/>
          <p:nvPr/>
        </p:nvPicPr>
        <p:blipFill>
          <a:blip r:embed="rId1"/>
          <a:stretch/>
        </p:blipFill>
        <p:spPr>
          <a:xfrm>
            <a:off x="1042920" y="189000"/>
            <a:ext cx="7561440" cy="5494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08T13:46:47Z</dcterms:created>
  <dc:creator>Roger Ibbett</dc:creator>
  <dc:description/>
  <dc:language>en-US</dc:language>
  <cp:lastModifiedBy>Roger Ibbett</cp:lastModifiedBy>
  <dcterms:modified xsi:type="dcterms:W3CDTF">2011-06-08T16:39:23Z</dcterms:modified>
  <cp:revision>3</cp:revision>
  <dc:subject/>
  <dc:title>Slide 1</dc:title>
</cp:coreProperties>
</file>